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8" r:id="rId13"/>
    <p:sldId id="269" r:id="rId14"/>
    <p:sldId id="270" r:id="rId15"/>
    <p:sldId id="271" r:id="rId16"/>
    <p:sldId id="272" r:id="rId17"/>
    <p:sldId id="274" r:id="rId1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516" y="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5/6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1520" y="323364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>
                <a:latin typeface="Times New Roman" pitchFamily="18" charset="0"/>
                <a:cs typeface="Times New Roman" pitchFamily="18" charset="0"/>
              </a:rPr>
              <a:t>PflaOR21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196554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42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64554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44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117" y="1469073"/>
            <a:ext cx="6271766" cy="3919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32686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49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117" y="1469073"/>
            <a:ext cx="6271766" cy="3919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470917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51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117" y="1469073"/>
            <a:ext cx="6271766" cy="3919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785803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60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997387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61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84461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62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549882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63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8748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25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27115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27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117" y="1469073"/>
            <a:ext cx="6271766" cy="3919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68002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29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117" y="1469073"/>
            <a:ext cx="6271766" cy="3919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78615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35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89276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36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117" y="1469073"/>
            <a:ext cx="6271766" cy="3919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52701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37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72889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9997"/>
            <a:ext cx="9144000" cy="22780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40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11938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323364"/>
            <a:ext cx="3672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smtClean="0">
                <a:latin typeface="Times New Roman" pitchFamily="18" charset="0"/>
                <a:cs typeface="Times New Roman" pitchFamily="18" charset="0"/>
              </a:rPr>
              <a:t>PflaOR41</a:t>
            </a:r>
            <a:endParaRPr lang="zh-CN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117" y="1469073"/>
            <a:ext cx="6271766" cy="3919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9465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7</Words>
  <Application>Microsoft Office PowerPoint</Application>
  <PresentationFormat>全屏显示(4:3)</PresentationFormat>
  <Paragraphs>17</Paragraphs>
  <Slides>1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7</vt:i4>
      </vt:variant>
    </vt:vector>
  </HeadingPairs>
  <TitlesOfParts>
    <vt:vector size="1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胡</cp:lastModifiedBy>
  <cp:revision>5</cp:revision>
  <dcterms:created xsi:type="dcterms:W3CDTF">2021-09-09T12:38:57Z</dcterms:created>
  <dcterms:modified xsi:type="dcterms:W3CDTF">2022-05-06T12:17:40Z</dcterms:modified>
</cp:coreProperties>
</file>